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73" r:id="rId3"/>
    <p:sldId id="259" r:id="rId4"/>
    <p:sldId id="274" r:id="rId5"/>
    <p:sldId id="275" r:id="rId6"/>
    <p:sldId id="27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469" autoAdjust="0"/>
  </p:normalViewPr>
  <p:slideViewPr>
    <p:cSldViewPr snapToGrid="0">
      <p:cViewPr varScale="1">
        <p:scale>
          <a:sx n="109" d="100"/>
          <a:sy n="109" d="100"/>
        </p:scale>
        <p:origin x="63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382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785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542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63069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0328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3594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4733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463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0896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56331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353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78178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94588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75349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498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5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812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216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431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6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9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247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3FD55-6054-4D10-8FEF-4F63136E0814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A76C7-1EF1-4735-8E1E-F79439830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574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8FF6C-63AE-44B6-B6A7-71AA94861EBE}" type="datetimeFigureOut">
              <a:rPr lang="en-US" smtClean="0"/>
              <a:pPr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A54BE6-990E-4AF8-8B39-F49ADA65ACA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191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850" name="Group 17"/>
          <p:cNvGrpSpPr>
            <a:grpSpLocks/>
          </p:cNvGrpSpPr>
          <p:nvPr/>
        </p:nvGrpSpPr>
        <p:grpSpPr bwMode="auto">
          <a:xfrm>
            <a:off x="5122915" y="704526"/>
            <a:ext cx="2286000" cy="2468880"/>
            <a:chOff x="5046574" y="633591"/>
            <a:chExt cx="2286147" cy="2468830"/>
          </a:xfrm>
        </p:grpSpPr>
        <p:pic>
          <p:nvPicPr>
            <p:cNvPr id="78864" name="Picture 5" descr="C:\Documents and Settings\Qing\Desktop\IP 04052016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66" t="43742" r="-1374" b="6748"/>
            <a:stretch/>
          </p:blipFill>
          <p:spPr bwMode="auto">
            <a:xfrm rot="16200000">
              <a:off x="4955233" y="724932"/>
              <a:ext cx="2468830" cy="2286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9" name="Straight Connector 8"/>
            <p:cNvCxnSpPr/>
            <p:nvPr/>
          </p:nvCxnSpPr>
          <p:spPr>
            <a:xfrm>
              <a:off x="6575384" y="1078406"/>
              <a:ext cx="27148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6575384" y="957759"/>
              <a:ext cx="27148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6596023" y="1372088"/>
              <a:ext cx="2730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6596023" y="805362"/>
              <a:ext cx="2730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6596023" y="1600684"/>
              <a:ext cx="2730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6618250" y="1764192"/>
              <a:ext cx="27306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6629362" y="2362668"/>
              <a:ext cx="27148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6662702" y="2786521"/>
              <a:ext cx="27148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852" name="TextBox 18"/>
          <p:cNvSpPr txBox="1">
            <a:spLocks noChangeArrowheads="1"/>
          </p:cNvSpPr>
          <p:nvPr/>
        </p:nvSpPr>
        <p:spPr bwMode="auto">
          <a:xfrm>
            <a:off x="7032625" y="728663"/>
            <a:ext cx="598488" cy="232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16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11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80</a:t>
            </a: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60</a:t>
            </a: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5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4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en-US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en-US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3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en-US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20</a:t>
            </a:r>
          </a:p>
        </p:txBody>
      </p:sp>
      <p:sp>
        <p:nvSpPr>
          <p:cNvPr id="78853" name="TextBox 19"/>
          <p:cNvSpPr txBox="1">
            <a:spLocks noChangeArrowheads="1"/>
          </p:cNvSpPr>
          <p:nvPr/>
        </p:nvSpPr>
        <p:spPr bwMode="auto">
          <a:xfrm>
            <a:off x="7750176" y="500063"/>
            <a:ext cx="21558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marL="342900" indent="-3429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Calibri Light" panose="020F0302020204030204" pitchFamily="34" charset="0"/>
              <a:buAutoNum type="arabicPeriod"/>
              <a:tabLst/>
              <a:defRPr/>
            </a:pPr>
            <a:r>
              <a:rPr kumimoji="0" lang="en-US" altLang="en-US" sz="12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put – total cell lysate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Calibri Light" panose="020F0302020204030204" pitchFamily="34" charset="0"/>
              <a:buAutoNum type="arabicPeriod"/>
              <a:tabLst/>
              <a:defRPr/>
            </a:pPr>
            <a:r>
              <a:rPr kumimoji="0" lang="en-US" altLang="en-US" sz="12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P with Ig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Calibri Light" panose="020F0302020204030204" pitchFamily="34" charset="0"/>
              <a:buAutoNum type="arabicPeriod"/>
              <a:tabLst/>
              <a:defRPr/>
            </a:pPr>
            <a:r>
              <a:rPr kumimoji="0" lang="en-US" altLang="en-US" sz="12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P with anti-DDR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Calibri Light" panose="020F0302020204030204" pitchFamily="34" charset="0"/>
              <a:buAutoNum type="arabicPeriod"/>
              <a:tabLst/>
              <a:defRPr/>
            </a:pPr>
            <a:r>
              <a:rPr kumimoji="0" lang="en-US" altLang="en-US" sz="12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P with anti-Periostin</a:t>
            </a:r>
          </a:p>
        </p:txBody>
      </p:sp>
      <p:sp>
        <p:nvSpPr>
          <p:cNvPr id="78854" name="TextBox 20"/>
          <p:cNvSpPr txBox="1">
            <a:spLocks noChangeArrowheads="1"/>
          </p:cNvSpPr>
          <p:nvPr/>
        </p:nvSpPr>
        <p:spPr bwMode="auto">
          <a:xfrm>
            <a:off x="5264203" y="500063"/>
            <a:ext cx="12889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1     </a:t>
            </a:r>
            <a:r>
              <a:rPr kumimoji="0" lang="en-US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2  </a:t>
            </a:r>
            <a:r>
              <a:rPr kumimoji="0" lang="en-US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    </a:t>
            </a:r>
            <a:r>
              <a:rPr kumimoji="0" lang="en-US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3    </a:t>
            </a:r>
            <a:r>
              <a:rPr kumimoji="0" lang="en-US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  4</a:t>
            </a:r>
            <a:endParaRPr kumimoji="0" lang="en-US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</p:txBody>
      </p:sp>
      <p:sp>
        <p:nvSpPr>
          <p:cNvPr id="78858" name="TextBox 25"/>
          <p:cNvSpPr txBox="1">
            <a:spLocks noChangeArrowheads="1"/>
          </p:cNvSpPr>
          <p:nvPr/>
        </p:nvSpPr>
        <p:spPr bwMode="auto">
          <a:xfrm>
            <a:off x="2975035" y="937132"/>
            <a:ext cx="145891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Anti-periostin</a:t>
            </a:r>
          </a:p>
        </p:txBody>
      </p:sp>
      <p:sp>
        <p:nvSpPr>
          <p:cNvPr id="2" name="Rectangle 1"/>
          <p:cNvSpPr/>
          <p:nvPr/>
        </p:nvSpPr>
        <p:spPr>
          <a:xfrm>
            <a:off x="5186556" y="996951"/>
            <a:ext cx="1465071" cy="303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332953" y="6346989"/>
            <a:ext cx="118027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 2A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V="1">
            <a:off x="4399304" y="1111180"/>
            <a:ext cx="699941" cy="108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1" b="26701"/>
          <a:stretch/>
        </p:blipFill>
        <p:spPr>
          <a:xfrm>
            <a:off x="5105401" y="3216273"/>
            <a:ext cx="2271764" cy="2528789"/>
          </a:xfrm>
          <a:prstGeom prst="rect">
            <a:avLst/>
          </a:prstGeom>
        </p:spPr>
      </p:pic>
      <p:sp>
        <p:nvSpPr>
          <p:cNvPr id="26" name="TextBox 25"/>
          <p:cNvSpPr txBox="1">
            <a:spLocks noChangeArrowheads="1"/>
          </p:cNvSpPr>
          <p:nvPr/>
        </p:nvSpPr>
        <p:spPr bwMode="auto">
          <a:xfrm>
            <a:off x="3067508" y="3714679"/>
            <a:ext cx="127396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Anti-DDR1</a:t>
            </a:r>
            <a:endParaRPr kumimoji="0" lang="en-US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+mn-cs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 flipV="1">
            <a:off x="4286990" y="3899623"/>
            <a:ext cx="699941" cy="108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/>
          <p:cNvSpPr/>
          <p:nvPr/>
        </p:nvSpPr>
        <p:spPr>
          <a:xfrm>
            <a:off x="4985496" y="3723775"/>
            <a:ext cx="1959818" cy="303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46806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4294967295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96" t="23163" r="14274" b="22894"/>
          <a:stretch/>
        </p:blipFill>
        <p:spPr>
          <a:xfrm>
            <a:off x="181957" y="4556369"/>
            <a:ext cx="6708370" cy="1828800"/>
          </a:xfrm>
        </p:spPr>
      </p:pic>
      <p:sp>
        <p:nvSpPr>
          <p:cNvPr id="5" name="TextBox 4"/>
          <p:cNvSpPr txBox="1"/>
          <p:nvPr/>
        </p:nvSpPr>
        <p:spPr>
          <a:xfrm>
            <a:off x="8431436" y="1312650"/>
            <a:ext cx="718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DR1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7133215" y="5009104"/>
            <a:ext cx="1107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/>
              <a:t>Postn</a:t>
            </a:r>
            <a:endParaRPr lang="en-US" sz="2400" dirty="0"/>
          </a:p>
        </p:txBody>
      </p:sp>
      <p:sp>
        <p:nvSpPr>
          <p:cNvPr id="11" name="TextBox 10"/>
          <p:cNvSpPr txBox="1"/>
          <p:nvPr/>
        </p:nvSpPr>
        <p:spPr>
          <a:xfrm>
            <a:off x="7107396" y="6404707"/>
            <a:ext cx="122625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2B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978521" y="4759267"/>
            <a:ext cx="4092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ontrol   Lysate      Anti-lgG  Anti-DDR  Anti-Postn</a:t>
            </a:r>
            <a:endParaRPr lang="en-US" sz="1400" b="1" dirty="0"/>
          </a:p>
        </p:txBody>
      </p:sp>
      <p:grpSp>
        <p:nvGrpSpPr>
          <p:cNvPr id="16" name="Group 15"/>
          <p:cNvGrpSpPr/>
          <p:nvPr/>
        </p:nvGrpSpPr>
        <p:grpSpPr>
          <a:xfrm>
            <a:off x="236101" y="2846846"/>
            <a:ext cx="8554355" cy="1645920"/>
            <a:chOff x="236101" y="2846846"/>
            <a:chExt cx="8554355" cy="1645920"/>
          </a:xfrm>
        </p:grpSpPr>
        <p:sp>
          <p:nvSpPr>
            <p:cNvPr id="6" name="TextBox 5"/>
            <p:cNvSpPr txBox="1"/>
            <p:nvPr/>
          </p:nvSpPr>
          <p:spPr>
            <a:xfrm>
              <a:off x="7407743" y="3208141"/>
              <a:ext cx="8895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 smtClean="0"/>
                <a:t>DDR2</a:t>
              </a:r>
              <a:endParaRPr lang="en-US" sz="2400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79" t="21297" r="12077" b="17191"/>
            <a:stretch/>
          </p:blipFill>
          <p:spPr>
            <a:xfrm>
              <a:off x="236101" y="2846846"/>
              <a:ext cx="6654226" cy="1645920"/>
            </a:xfrm>
            <a:prstGeom prst="rect">
              <a:avLst/>
            </a:prstGeom>
          </p:spPr>
        </p:pic>
        <p:cxnSp>
          <p:nvCxnSpPr>
            <p:cNvPr id="8" name="Straight Arrow Connector 7"/>
            <p:cNvCxnSpPr/>
            <p:nvPr/>
          </p:nvCxnSpPr>
          <p:spPr>
            <a:xfrm>
              <a:off x="461105" y="3520040"/>
              <a:ext cx="1443715" cy="31262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978521" y="3188400"/>
              <a:ext cx="7120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DDR2</a:t>
              </a:r>
              <a:endParaRPr lang="en-US" dirty="0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 flipV="1">
              <a:off x="5328140" y="3740146"/>
              <a:ext cx="2079603" cy="305874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6914621" y="3808288"/>
              <a:ext cx="18758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on-specific band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78521" y="2970908"/>
              <a:ext cx="5703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                      Control          Lysate     Anti-lgG   Anti-DDR   Anti-Postn  Marker</a:t>
              </a:r>
              <a:endParaRPr lang="en-US" sz="1400" b="1" dirty="0"/>
            </a:p>
          </p:txBody>
        </p:sp>
      </p:grpSp>
      <p:cxnSp>
        <p:nvCxnSpPr>
          <p:cNvPr id="18" name="Straight Arrow Connector 17"/>
          <p:cNvCxnSpPr/>
          <p:nvPr/>
        </p:nvCxnSpPr>
        <p:spPr>
          <a:xfrm flipH="1">
            <a:off x="4578377" y="5269942"/>
            <a:ext cx="2508223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5697415" y="3535671"/>
            <a:ext cx="1710329" cy="1563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101" y="888380"/>
            <a:ext cx="6654226" cy="1877731"/>
          </a:xfrm>
          <a:prstGeom prst="rect">
            <a:avLst/>
          </a:prstGeom>
        </p:spPr>
      </p:pic>
      <p:cxnSp>
        <p:nvCxnSpPr>
          <p:cNvPr id="25" name="Straight Arrow Connector 24"/>
          <p:cNvCxnSpPr/>
          <p:nvPr/>
        </p:nvCxnSpPr>
        <p:spPr>
          <a:xfrm flipH="1">
            <a:off x="6623321" y="1497316"/>
            <a:ext cx="1710329" cy="1563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77722" y="580603"/>
            <a:ext cx="6505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ontrol                      Lysate                  Anti-lgG                  Anti-DDR         Anti-Postn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5854338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188242" y="6271085"/>
            <a:ext cx="1098280" cy="3786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 4A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87569" y="378551"/>
            <a:ext cx="4163371" cy="4327422"/>
            <a:chOff x="2157587" y="190982"/>
            <a:chExt cx="4163371" cy="4327422"/>
          </a:xfrm>
        </p:grpSpPr>
        <p:sp>
          <p:nvSpPr>
            <p:cNvPr id="16" name="TextBox 15"/>
            <p:cNvSpPr txBox="1"/>
            <p:nvPr/>
          </p:nvSpPr>
          <p:spPr>
            <a:xfrm flipH="1">
              <a:off x="5215000" y="282966"/>
              <a:ext cx="11059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Postn</a:t>
              </a: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5µg/ml)</a:t>
              </a:r>
              <a:endPara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263486" y="190982"/>
              <a:ext cx="23209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      +       +       +      +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2157587" y="560314"/>
              <a:ext cx="3513450" cy="3958090"/>
              <a:chOff x="2157587" y="560314"/>
              <a:chExt cx="3513450" cy="3958090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2157587" y="1648878"/>
                <a:ext cx="12917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DDR1</a:t>
                </a:r>
                <a:endPara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2303712" y="3381023"/>
                <a:ext cx="12917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DDR1</a:t>
                </a:r>
                <a:endPara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26" t="50954" r="52920" b="20275"/>
              <a:stretch/>
            </p:blipFill>
            <p:spPr>
              <a:xfrm>
                <a:off x="3129490" y="2907024"/>
                <a:ext cx="2541547" cy="1611380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3036318" y="615039"/>
                <a:ext cx="24737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Con    0.5       1          1.5       2         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 flipV="1">
                <a:off x="3736425" y="560314"/>
                <a:ext cx="1637973" cy="8857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46" t="28351" r="43602" b="23383"/>
              <a:stretch/>
            </p:blipFill>
            <p:spPr>
              <a:xfrm>
                <a:off x="3108139" y="1151096"/>
                <a:ext cx="2562898" cy="1640406"/>
              </a:xfrm>
              <a:prstGeom prst="rect">
                <a:avLst/>
              </a:prstGeom>
            </p:spPr>
          </p:pic>
        </p:grpSp>
      </p:grpSp>
      <p:grpSp>
        <p:nvGrpSpPr>
          <p:cNvPr id="6" name="Group 5"/>
          <p:cNvGrpSpPr/>
          <p:nvPr/>
        </p:nvGrpSpPr>
        <p:grpSpPr>
          <a:xfrm>
            <a:off x="6209324" y="563217"/>
            <a:ext cx="4074278" cy="4217932"/>
            <a:chOff x="4177324" y="517620"/>
            <a:chExt cx="4074278" cy="4217932"/>
          </a:xfrm>
        </p:grpSpPr>
        <p:sp>
          <p:nvSpPr>
            <p:cNvPr id="7" name="TextBox 6"/>
            <p:cNvSpPr txBox="1"/>
            <p:nvPr/>
          </p:nvSpPr>
          <p:spPr>
            <a:xfrm>
              <a:off x="6959830" y="2082913"/>
              <a:ext cx="12917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DDR2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8" name="Picture 7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13" t="37713" r="42155" b="33602"/>
            <a:stretch/>
          </p:blipFill>
          <p:spPr>
            <a:xfrm>
              <a:off x="4186289" y="3065014"/>
              <a:ext cx="2782507" cy="1670538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6968796" y="3867992"/>
              <a:ext cx="8700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DDR2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09" t="35692" r="58809" b="26352"/>
            <a:stretch/>
          </p:blipFill>
          <p:spPr>
            <a:xfrm>
              <a:off x="4177324" y="1338665"/>
              <a:ext cx="2791472" cy="1640406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flipH="1">
              <a:off x="6364971" y="609604"/>
              <a:ext cx="11059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Postn</a:t>
              </a: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5µg/ml)</a:t>
              </a:r>
              <a:endPara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413457" y="517620"/>
              <a:ext cx="23209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-       +       +       +      +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86289" y="941677"/>
              <a:ext cx="24737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  Con    0.5       1          1.5       2         </a:t>
              </a:r>
              <a:endPara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 flipV="1">
              <a:off x="4886396" y="886952"/>
              <a:ext cx="1637973" cy="885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654824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44" t="34301" r="21861" b="28981"/>
          <a:stretch/>
        </p:blipFill>
        <p:spPr>
          <a:xfrm>
            <a:off x="352405" y="3147332"/>
            <a:ext cx="3406795" cy="179977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68753" y="3847163"/>
            <a:ext cx="12257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DDR1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79" t="39661" r="24022" b="25479"/>
          <a:stretch/>
        </p:blipFill>
        <p:spPr>
          <a:xfrm>
            <a:off x="352405" y="1349830"/>
            <a:ext cx="3406795" cy="178063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68753" y="1962152"/>
            <a:ext cx="12257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DDR1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679709" y="2254335"/>
            <a:ext cx="13808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AKT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868753" y="5504059"/>
            <a:ext cx="1499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-catenin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286504" y="5684828"/>
            <a:ext cx="13808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388725" y="3918999"/>
            <a:ext cx="13808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KT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86" t="50698" r="12075" b="19002"/>
          <a:stretch/>
        </p:blipFill>
        <p:spPr>
          <a:xfrm>
            <a:off x="5817232" y="5065486"/>
            <a:ext cx="3413854" cy="181956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9267736" y="6415381"/>
            <a:ext cx="1128968" cy="3786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4</a:t>
            </a:r>
            <a:r>
              <a:rPr kumimoji="0" lang="en-US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  <a:endParaRPr kumimoji="0" 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79" t="43890" r="51494" b="38254"/>
          <a:stretch/>
        </p:blipFill>
        <p:spPr>
          <a:xfrm>
            <a:off x="352405" y="5065486"/>
            <a:ext cx="3406795" cy="1640114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96339" y="1063974"/>
            <a:ext cx="3524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Con        0.5          1              2          4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924414" y="1000355"/>
            <a:ext cx="2483804" cy="21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flipH="1">
            <a:off x="3611418" y="843866"/>
            <a:ext cx="1105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Postn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5µg/ml)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42790" y="556185"/>
            <a:ext cx="2965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         +         +           +        +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92" t="37287" r="24474" b="44662"/>
          <a:stretch/>
        </p:blipFill>
        <p:spPr>
          <a:xfrm>
            <a:off x="5838722" y="3189113"/>
            <a:ext cx="3392364" cy="1847273"/>
          </a:xfrm>
          <a:prstGeom prst="rect">
            <a:avLst/>
          </a:prstGeom>
          <a:effectLst>
            <a:outerShdw sx="1000" sy="1000" algn="ctr" rotWithShape="0">
              <a:srgbClr val="000000"/>
            </a:outerShdw>
          </a:effectLst>
        </p:spPr>
      </p:pic>
      <p:pic>
        <p:nvPicPr>
          <p:cNvPr id="32" name="Picture 31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86" t="31046" r="22359" b="37776"/>
          <a:stretch/>
        </p:blipFill>
        <p:spPr>
          <a:xfrm>
            <a:off x="5875667" y="1467923"/>
            <a:ext cx="3318473" cy="166254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5875667" y="1202479"/>
            <a:ext cx="3524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Con        0.5          1              2          4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 flipV="1">
            <a:off x="6603742" y="1138860"/>
            <a:ext cx="2483804" cy="21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 flipH="1">
            <a:off x="9290746" y="982371"/>
            <a:ext cx="1105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Postn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5µg/ml)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22118" y="694690"/>
            <a:ext cx="2965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         +         +           +        +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634512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865457" y="1140198"/>
            <a:ext cx="7544636" cy="4837973"/>
            <a:chOff x="1874694" y="-14348"/>
            <a:chExt cx="7544636" cy="4837973"/>
          </a:xfrm>
        </p:grpSpPr>
        <p:sp>
          <p:nvSpPr>
            <p:cNvPr id="15" name="TextBox 14"/>
            <p:cNvSpPr txBox="1"/>
            <p:nvPr/>
          </p:nvSpPr>
          <p:spPr>
            <a:xfrm>
              <a:off x="1926786" y="718472"/>
              <a:ext cx="69559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 -    20  60    -     20   60         </a:t>
              </a:r>
              <a:r>
                <a:rPr kumimoji="0" lang="en-US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inutes</a:t>
              </a: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, </a:t>
              </a:r>
              <a:r>
                <a:rPr kumimoji="0" lang="en-US" sz="16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rPostn</a:t>
              </a: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, 5ug/ml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874694" y="-14348"/>
              <a:ext cx="7544636" cy="4837973"/>
              <a:chOff x="1874694" y="-14348"/>
              <a:chExt cx="7544636" cy="4837973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32" t="64317" r="60205" b="4475"/>
              <a:stretch/>
            </p:blipFill>
            <p:spPr>
              <a:xfrm>
                <a:off x="1874694" y="4119236"/>
                <a:ext cx="2286000" cy="704389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59" t="29036" r="53180" b="15361"/>
              <a:stretch/>
            </p:blipFill>
            <p:spPr>
              <a:xfrm>
                <a:off x="1893028" y="1088591"/>
                <a:ext cx="2286000" cy="914375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811" t="17489" r="47875" b="37382"/>
              <a:stretch/>
            </p:blipFill>
            <p:spPr>
              <a:xfrm>
                <a:off x="1903408" y="3051975"/>
                <a:ext cx="2194560" cy="925551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4262496" y="1319504"/>
                <a:ext cx="15082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-AKT (Ser473)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114974" y="2327725"/>
                <a:ext cx="91377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n AKT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205597" y="4317541"/>
                <a:ext cx="12757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otal 4E-BP1</a:t>
                </a:r>
              </a:p>
            </p:txBody>
          </p:sp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44" t="19614" r="58527" b="58143"/>
              <a:stretch/>
            </p:blipFill>
            <p:spPr>
              <a:xfrm>
                <a:off x="1920414" y="2102794"/>
                <a:ext cx="2194560" cy="825190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4114974" y="3384512"/>
                <a:ext cx="14409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otal </a:t>
                </a:r>
                <a:r>
                  <a:rPr kumimoji="0" lang="el-GR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β</a:t>
                </a: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</a:t>
                </a:r>
                <a:r>
                  <a:rPr kumimoji="0" lang="en-US" sz="14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atenin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204501" y="312504"/>
                <a:ext cx="721482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   -                  </a:t>
                </a:r>
                <a:r>
                  <a:rPr kumimoji="0" lang="en-US" sz="16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+                   DDR1 </a:t>
                </a: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inhibitor, 1uM, 24h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cxnSp>
            <p:nvCxnSpPr>
              <p:cNvPr id="24" name="Straight Connector 23"/>
              <p:cNvCxnSpPr/>
              <p:nvPr/>
            </p:nvCxnSpPr>
            <p:spPr>
              <a:xfrm>
                <a:off x="2230813" y="337715"/>
                <a:ext cx="1322975" cy="8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>
                <a:off x="2484340" y="-14348"/>
                <a:ext cx="136418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         </a:t>
                </a:r>
                <a:r>
                  <a:rPr kumimoji="0" lang="en-US" sz="16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F60</a:t>
                </a:r>
                <a:endPara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2031953" y="679686"/>
                <a:ext cx="80554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3042980" y="687123"/>
                <a:ext cx="80554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5224862" y="683409"/>
                <a:ext cx="805544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" name="TextBox 2"/>
          <p:cNvSpPr txBox="1"/>
          <p:nvPr/>
        </p:nvSpPr>
        <p:spPr>
          <a:xfrm flipH="1">
            <a:off x="4400832" y="6405116"/>
            <a:ext cx="121312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4C: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722596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3</TotalTime>
  <Words>166</Words>
  <Application>Microsoft Office PowerPoint</Application>
  <PresentationFormat>Widescreen</PresentationFormat>
  <Paragraphs>6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, Tianzhen</dc:creator>
  <cp:lastModifiedBy>Attur, Mukundan</cp:lastModifiedBy>
  <cp:revision>69</cp:revision>
  <dcterms:created xsi:type="dcterms:W3CDTF">2020-02-26T15:26:51Z</dcterms:created>
  <dcterms:modified xsi:type="dcterms:W3CDTF">2020-03-11T18:04:19Z</dcterms:modified>
</cp:coreProperties>
</file>